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-1830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4E8E95F-95C3-4990-A241-6491A90F2666}" type="datetimeFigureOut">
              <a:rPr lang="en-US" smtClean="0"/>
              <a:t>1/27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8C54EA4-983F-4EB9-939F-A80307400E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38186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4A2B53C-1EF0-4C57-9772-87A44A65BB48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42922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7135B-BE0F-43C4-B608-E2629CC1AC12}" type="datetimeFigureOut">
              <a:rPr lang="en-US" smtClean="0"/>
              <a:t>1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30A6A-0A9F-4DD8-BDD7-E1556B86C3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9771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7135B-BE0F-43C4-B608-E2629CC1AC12}" type="datetimeFigureOut">
              <a:rPr lang="en-US" smtClean="0"/>
              <a:t>1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30A6A-0A9F-4DD8-BDD7-E1556B86C3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46568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7135B-BE0F-43C4-B608-E2629CC1AC12}" type="datetimeFigureOut">
              <a:rPr lang="en-US" smtClean="0"/>
              <a:t>1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30A6A-0A9F-4DD8-BDD7-E1556B86C3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26916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7135B-BE0F-43C4-B608-E2629CC1AC12}" type="datetimeFigureOut">
              <a:rPr lang="en-US" smtClean="0"/>
              <a:t>1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30A6A-0A9F-4DD8-BDD7-E1556B86C3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29080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7135B-BE0F-43C4-B608-E2629CC1AC12}" type="datetimeFigureOut">
              <a:rPr lang="en-US" smtClean="0"/>
              <a:t>1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30A6A-0A9F-4DD8-BDD7-E1556B86C3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09293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7135B-BE0F-43C4-B608-E2629CC1AC12}" type="datetimeFigureOut">
              <a:rPr lang="en-US" smtClean="0"/>
              <a:t>1/2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30A6A-0A9F-4DD8-BDD7-E1556B86C3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21727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7135B-BE0F-43C4-B608-E2629CC1AC12}" type="datetimeFigureOut">
              <a:rPr lang="en-US" smtClean="0"/>
              <a:t>1/27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30A6A-0A9F-4DD8-BDD7-E1556B86C3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5775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7135B-BE0F-43C4-B608-E2629CC1AC12}" type="datetimeFigureOut">
              <a:rPr lang="en-US" smtClean="0"/>
              <a:t>1/27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30A6A-0A9F-4DD8-BDD7-E1556B86C3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2654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7135B-BE0F-43C4-B608-E2629CC1AC12}" type="datetimeFigureOut">
              <a:rPr lang="en-US" smtClean="0"/>
              <a:t>1/27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30A6A-0A9F-4DD8-BDD7-E1556B86C3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61299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7135B-BE0F-43C4-B608-E2629CC1AC12}" type="datetimeFigureOut">
              <a:rPr lang="en-US" smtClean="0"/>
              <a:t>1/2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30A6A-0A9F-4DD8-BDD7-E1556B86C3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44950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7135B-BE0F-43C4-B608-E2629CC1AC12}" type="datetimeFigureOut">
              <a:rPr lang="en-US" smtClean="0"/>
              <a:t>1/2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30A6A-0A9F-4DD8-BDD7-E1556B86C3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25290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E7135B-BE0F-43C4-B608-E2629CC1AC12}" type="datetimeFigureOut">
              <a:rPr lang="en-US" smtClean="0"/>
              <a:t>1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830A6A-0A9F-4DD8-BDD7-E1556B86C3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0813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8" name="Group 97"/>
          <p:cNvGrpSpPr/>
          <p:nvPr/>
        </p:nvGrpSpPr>
        <p:grpSpPr>
          <a:xfrm>
            <a:off x="5454650" y="939004"/>
            <a:ext cx="2690284" cy="1900724"/>
            <a:chOff x="4472427" y="866255"/>
            <a:chExt cx="2405958" cy="1708419"/>
          </a:xfrm>
        </p:grpSpPr>
        <p:pic>
          <p:nvPicPr>
            <p:cNvPr id="69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38" r="4798" b="10035"/>
            <a:stretch>
              <a:fillRect/>
            </a:stretch>
          </p:blipFill>
          <p:spPr bwMode="auto">
            <a:xfrm>
              <a:off x="4780981" y="866255"/>
              <a:ext cx="2097404" cy="15117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93" name="TextBox 92"/>
            <p:cNvSpPr txBox="1"/>
            <p:nvPr/>
          </p:nvSpPr>
          <p:spPr>
            <a:xfrm rot="16200000">
              <a:off x="4063262" y="1420025"/>
              <a:ext cx="1238972" cy="420642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lative protein expression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Rectangle 95"/>
            <p:cNvSpPr/>
            <p:nvPr/>
          </p:nvSpPr>
          <p:spPr>
            <a:xfrm>
              <a:off x="5176185" y="2320028"/>
              <a:ext cx="1495797" cy="25464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reatment time (hr)</a:t>
              </a:r>
              <a:endParaRPr lang="en-US" sz="1200" dirty="0"/>
            </a:p>
          </p:txBody>
        </p:sp>
      </p:grpSp>
      <p:pic>
        <p:nvPicPr>
          <p:cNvPr id="65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827" r="17759" b="19988"/>
          <a:stretch>
            <a:fillRect/>
          </a:stretch>
        </p:blipFill>
        <p:spPr bwMode="auto">
          <a:xfrm>
            <a:off x="2164821" y="2575533"/>
            <a:ext cx="2473907" cy="30283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6" name="Picture 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907" r="15573" b="19908"/>
          <a:stretch>
            <a:fillRect/>
          </a:stretch>
        </p:blipFill>
        <p:spPr bwMode="auto">
          <a:xfrm>
            <a:off x="2164821" y="3272550"/>
            <a:ext cx="2473907" cy="30283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7" name="Picture 4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2" t="14509" r="12866" b="21910"/>
          <a:stretch>
            <a:fillRect/>
          </a:stretch>
        </p:blipFill>
        <p:spPr bwMode="auto">
          <a:xfrm>
            <a:off x="2164821" y="2924399"/>
            <a:ext cx="2473907" cy="30283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1" name="TextBox 70"/>
          <p:cNvSpPr txBox="1"/>
          <p:nvPr/>
        </p:nvSpPr>
        <p:spPr>
          <a:xfrm>
            <a:off x="1595337" y="2581147"/>
            <a:ext cx="5951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ER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1569814" y="2930013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1541010" y="3278164"/>
            <a:ext cx="6494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Rectangle 73"/>
          <p:cNvSpPr/>
          <p:nvPr/>
        </p:nvSpPr>
        <p:spPr>
          <a:xfrm>
            <a:off x="965154" y="2303682"/>
            <a:ext cx="130809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rhexiline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2252472" y="2312149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2590057" y="2312149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2953043" y="2312149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3290391" y="2312149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3577411" y="2312149"/>
            <a:ext cx="3985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.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3931614" y="2312149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4277587" y="2312149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1223676" y="1286645"/>
            <a:ext cx="5951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ER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1198153" y="1612786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1169349" y="1935026"/>
            <a:ext cx="6494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6" name="Picture 85"/>
          <p:cNvPicPr>
            <a:picLocks noChangeAspect="1"/>
          </p:cNvPicPr>
          <p:nvPr/>
        </p:nvPicPr>
        <p:blipFill>
          <a:blip r:embed="rId7" cstate="print">
            <a:lum bright="3000"/>
          </a:blip>
          <a:stretch>
            <a:fillRect/>
          </a:stretch>
        </p:blipFill>
        <p:spPr>
          <a:xfrm>
            <a:off x="1795276" y="1286764"/>
            <a:ext cx="3566230" cy="279850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87" name="Picture 86"/>
          <p:cNvPicPr>
            <a:picLocks noChangeAspect="1"/>
          </p:cNvPicPr>
          <p:nvPr/>
        </p:nvPicPr>
        <p:blipFill>
          <a:blip r:embed="rId8" cstate="print"/>
          <a:stretch>
            <a:fillRect/>
          </a:stretch>
        </p:blipFill>
        <p:spPr>
          <a:xfrm>
            <a:off x="1795276" y="1612905"/>
            <a:ext cx="3566230" cy="279850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88" name="Picture 87"/>
          <p:cNvPicPr>
            <a:picLocks noChangeAspect="1"/>
          </p:cNvPicPr>
          <p:nvPr/>
        </p:nvPicPr>
        <p:blipFill>
          <a:blip r:embed="rId9" cstate="print"/>
          <a:stretch>
            <a:fillRect/>
          </a:stretch>
        </p:blipFill>
        <p:spPr>
          <a:xfrm>
            <a:off x="1795276" y="1935165"/>
            <a:ext cx="3566234" cy="279810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37" name="Picture 3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2129621" y="5027536"/>
            <a:ext cx="2503804" cy="383914"/>
          </a:xfrm>
          <a:prstGeom prst="rect">
            <a:avLst/>
          </a:prstGeom>
          <a:noFill/>
          <a:ln w="9525">
            <a:solidFill>
              <a:sysClr val="windowText" lastClr="000000"/>
            </a:solidFill>
            <a:miter lim="800000"/>
            <a:headEnd/>
            <a:tailEnd/>
          </a:ln>
        </p:spPr>
      </p:pic>
      <p:pic>
        <p:nvPicPr>
          <p:cNvPr id="38" name="Picture 5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2129621" y="4603531"/>
            <a:ext cx="2503804" cy="383914"/>
          </a:xfrm>
          <a:prstGeom prst="rect">
            <a:avLst/>
          </a:prstGeom>
          <a:noFill/>
          <a:ln w="9525">
            <a:solidFill>
              <a:sysClr val="windowText" lastClr="000000"/>
            </a:solidFill>
            <a:miter lim="800000"/>
            <a:headEnd/>
            <a:tailEnd/>
          </a:ln>
        </p:spPr>
      </p:pic>
      <p:pic>
        <p:nvPicPr>
          <p:cNvPr id="39" name="Picture 8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2129621" y="4176260"/>
            <a:ext cx="2503806" cy="383234"/>
          </a:xfrm>
          <a:prstGeom prst="rect">
            <a:avLst/>
          </a:prstGeom>
          <a:noFill/>
          <a:ln w="9525">
            <a:solidFill>
              <a:sysClr val="windowText" lastClr="000000"/>
            </a:solidFill>
            <a:miter lim="800000"/>
            <a:headEnd/>
            <a:tailEnd/>
          </a:ln>
        </p:spPr>
      </p:pic>
      <p:sp>
        <p:nvSpPr>
          <p:cNvPr id="40" name="TextBox 39"/>
          <p:cNvSpPr txBox="1"/>
          <p:nvPr/>
        </p:nvSpPr>
        <p:spPr>
          <a:xfrm>
            <a:off x="2177797" y="3913845"/>
            <a:ext cx="2494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0       1       3      5     7.5    10   15</a:t>
            </a:r>
            <a:endParaRPr kumimoji="0" lang="en-US" sz="12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965154" y="3913766"/>
            <a:ext cx="12653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rhexiline</a:t>
            </a:r>
            <a:r>
              <a:rPr kumimoji="0" lang="en-US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(µM)</a:t>
            </a:r>
            <a:endParaRPr kumimoji="0" lang="en-US" sz="12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Straight Connector 43"/>
          <p:cNvCxnSpPr/>
          <p:nvPr/>
        </p:nvCxnSpPr>
        <p:spPr>
          <a:xfrm flipV="1">
            <a:off x="2129621" y="3922233"/>
            <a:ext cx="2503803" cy="890"/>
          </a:xfrm>
          <a:prstGeom prst="line">
            <a:avLst/>
          </a:prstGeom>
          <a:noFill/>
          <a:ln w="9525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</a:ln>
          <a:effectLst/>
        </p:spPr>
      </p:cxnSp>
      <p:sp>
        <p:nvSpPr>
          <p:cNvPr id="45" name="TextBox 44"/>
          <p:cNvSpPr txBox="1"/>
          <p:nvPr/>
        </p:nvSpPr>
        <p:spPr>
          <a:xfrm>
            <a:off x="2831582" y="3665502"/>
            <a:ext cx="1099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kumimoji="0" lang="en-US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hr treatment</a:t>
            </a:r>
            <a:endParaRPr kumimoji="0" lang="en-US" sz="12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1562729" y="4228508"/>
            <a:ext cx="5951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HER3</a:t>
            </a:r>
            <a:endParaRPr kumimoji="0" lang="en-US" sz="12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1425898" y="4656989"/>
            <a:ext cx="7319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0" lang="en-US" sz="12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-HER3</a:t>
            </a:r>
            <a:endParaRPr kumimoji="0" lang="en-US" sz="12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1508402" y="5080994"/>
            <a:ext cx="6494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l-GR" sz="12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kern="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a</a:t>
            </a:r>
            <a:r>
              <a:rPr kumimoji="0" lang="en-US" sz="1200" b="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tin</a:t>
            </a:r>
            <a:endParaRPr kumimoji="0" lang="en-US" sz="12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5361510" y="793591"/>
            <a:ext cx="3143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/>
                <a:cs typeface="Arial"/>
              </a:rPr>
              <a:t>B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75" name="Rectangle 74"/>
          <p:cNvSpPr/>
          <p:nvPr/>
        </p:nvSpPr>
        <p:spPr>
          <a:xfrm>
            <a:off x="650745" y="793591"/>
            <a:ext cx="36607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A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702496" y="2240376"/>
            <a:ext cx="3143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/>
                <a:cs typeface="Arial"/>
              </a:rPr>
              <a:t>C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5361510" y="2817961"/>
            <a:ext cx="3143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712402" y="3673969"/>
            <a:ext cx="3044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/>
                <a:cs typeface="Arial"/>
              </a:rPr>
              <a:t>E</a:t>
            </a:r>
            <a:endParaRPr lang="en-US" sz="1400" b="1" dirty="0">
              <a:latin typeface="Arial"/>
              <a:cs typeface="Arial"/>
            </a:endParaRPr>
          </a:p>
        </p:txBody>
      </p:sp>
      <p:grpSp>
        <p:nvGrpSpPr>
          <p:cNvPr id="97" name="Group 96"/>
          <p:cNvGrpSpPr/>
          <p:nvPr/>
        </p:nvGrpSpPr>
        <p:grpSpPr>
          <a:xfrm>
            <a:off x="5454648" y="3024508"/>
            <a:ext cx="2690287" cy="1965277"/>
            <a:chOff x="4462368" y="2759314"/>
            <a:chExt cx="2419650" cy="1700388"/>
          </a:xfrm>
        </p:grpSpPr>
        <p:pic>
          <p:nvPicPr>
            <p:cNvPr id="70" name="Picture 3"/>
            <p:cNvPicPr>
              <a:picLocks noChangeAspect="1"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20" r="5116" b="13948"/>
            <a:stretch>
              <a:fillRect/>
            </a:stretch>
          </p:blipFill>
          <p:spPr bwMode="auto">
            <a:xfrm>
              <a:off x="4772680" y="2759314"/>
              <a:ext cx="2109338" cy="14607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94" name="TextBox 93"/>
            <p:cNvSpPr txBox="1"/>
            <p:nvPr/>
          </p:nvSpPr>
          <p:spPr>
            <a:xfrm rot="16200000">
              <a:off x="4050494" y="3323933"/>
              <a:ext cx="1238972" cy="415223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lative protein expression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Rectangle 94"/>
            <p:cNvSpPr/>
            <p:nvPr/>
          </p:nvSpPr>
          <p:spPr>
            <a:xfrm>
              <a:off x="5277228" y="4220038"/>
              <a:ext cx="1308095" cy="23966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erhexiline (µM)</a:t>
              </a:r>
              <a:endParaRPr lang="en-US" sz="1200" dirty="0"/>
            </a:p>
          </p:txBody>
        </p:sp>
      </p:grpSp>
      <p:sp>
        <p:nvSpPr>
          <p:cNvPr id="100" name="Rectangle 99"/>
          <p:cNvSpPr/>
          <p:nvPr/>
        </p:nvSpPr>
        <p:spPr>
          <a:xfrm>
            <a:off x="679197" y="1018929"/>
            <a:ext cx="122807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1200" dirty="0" smtClean="0">
                <a:latin typeface="Arial"/>
                <a:cs typeface="Arial"/>
              </a:rPr>
              <a:t>Perhexiline (hr)</a:t>
            </a:r>
            <a:endParaRPr lang="en-US" sz="1200" dirty="0"/>
          </a:p>
        </p:txBody>
      </p:sp>
      <p:sp>
        <p:nvSpPr>
          <p:cNvPr id="101" name="TextBox 100"/>
          <p:cNvSpPr txBox="1"/>
          <p:nvPr/>
        </p:nvSpPr>
        <p:spPr>
          <a:xfrm>
            <a:off x="1814131" y="1010462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0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2152427" y="1010462"/>
            <a:ext cx="3985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0.5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2566926" y="1010462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1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2939090" y="1010462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2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3294320" y="1010462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3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3658017" y="1010462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4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4021714" y="1010462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5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4368477" y="1010462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6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4723707" y="1010462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7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5053536" y="1010462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8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3401774" y="6010268"/>
            <a:ext cx="21050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S2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984286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71</Words>
  <Application>Microsoft Office PowerPoint</Application>
  <PresentationFormat>On-screen Show (4:3)</PresentationFormat>
  <Paragraphs>4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Duke Medicin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iu-Rong Ren, Ph.D.</dc:creator>
  <cp:lastModifiedBy>Xiu-Rong Ren, Ph.D.</cp:lastModifiedBy>
  <cp:revision>7</cp:revision>
  <dcterms:created xsi:type="dcterms:W3CDTF">2015-01-27T16:19:41Z</dcterms:created>
  <dcterms:modified xsi:type="dcterms:W3CDTF">2015-01-27T16:23:31Z</dcterms:modified>
</cp:coreProperties>
</file>